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300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1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1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5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7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74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4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6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52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44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99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24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52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0B960DB-ACA9-40CD-9FF6-735E93029B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8695" y="3657007"/>
            <a:ext cx="4758162" cy="4651639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842C56F-46EA-4553-BA7C-192EF977977B}"/>
              </a:ext>
            </a:extLst>
          </p:cNvPr>
          <p:cNvSpPr/>
          <p:nvPr/>
        </p:nvSpPr>
        <p:spPr>
          <a:xfrm>
            <a:off x="3887331" y="8111651"/>
            <a:ext cx="731550" cy="3939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77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C28549A-397D-4FBB-9CBC-E85E1DA71734}"/>
              </a:ext>
            </a:extLst>
          </p:cNvPr>
          <p:cNvSpPr/>
          <p:nvPr/>
        </p:nvSpPr>
        <p:spPr>
          <a:xfrm rot="16200000">
            <a:off x="1022573" y="5423524"/>
            <a:ext cx="726526" cy="3967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77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F758DA8E-7285-4ACA-A67B-022BF41D2AAA}"/>
              </a:ext>
            </a:extLst>
          </p:cNvPr>
          <p:cNvCxnSpPr>
            <a:cxnSpLocks/>
          </p:cNvCxnSpPr>
          <p:nvPr/>
        </p:nvCxnSpPr>
        <p:spPr>
          <a:xfrm>
            <a:off x="1664211" y="8038281"/>
            <a:ext cx="353844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33006BB5-D0FB-472A-9D06-F493AA2B499A}"/>
              </a:ext>
            </a:extLst>
          </p:cNvPr>
          <p:cNvCxnSpPr>
            <a:cxnSpLocks/>
          </p:cNvCxnSpPr>
          <p:nvPr/>
        </p:nvCxnSpPr>
        <p:spPr>
          <a:xfrm flipV="1">
            <a:off x="1658594" y="5104646"/>
            <a:ext cx="0" cy="29366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D5F3BF96-F415-44F6-899E-AE9D89A14107}"/>
              </a:ext>
            </a:extLst>
          </p:cNvPr>
          <p:cNvSpPr txBox="1"/>
          <p:nvPr/>
        </p:nvSpPr>
        <p:spPr>
          <a:xfrm>
            <a:off x="2964666" y="8068054"/>
            <a:ext cx="641522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7155CBA-92C8-42FB-9B0A-42674B12E634}"/>
              </a:ext>
            </a:extLst>
          </p:cNvPr>
          <p:cNvSpPr txBox="1"/>
          <p:nvPr/>
        </p:nvSpPr>
        <p:spPr>
          <a:xfrm rot="16200000">
            <a:off x="783502" y="6204464"/>
            <a:ext cx="1376402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gp100-Tet+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34C27B82-1DD7-4C72-98C9-46FAB19B1F23}"/>
              </a:ext>
            </a:extLst>
          </p:cNvPr>
          <p:cNvGrpSpPr/>
          <p:nvPr/>
        </p:nvGrpSpPr>
        <p:grpSpPr>
          <a:xfrm>
            <a:off x="6395164" y="3680666"/>
            <a:ext cx="4787753" cy="4767824"/>
            <a:chOff x="3112483" y="2397043"/>
            <a:chExt cx="2693111" cy="2681901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E179F8C-93D1-4CAB-973B-12F50A8CCC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49530" y="2397043"/>
              <a:ext cx="2656064" cy="2614563"/>
            </a:xfrm>
            <a:prstGeom prst="rect">
              <a:avLst/>
            </a:prstGeom>
          </p:spPr>
        </p:pic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280F3F11-11E0-46BF-91E4-0F70B43D004A}"/>
                </a:ext>
              </a:extLst>
            </p:cNvPr>
            <p:cNvSpPr/>
            <p:nvPr/>
          </p:nvSpPr>
          <p:spPr>
            <a:xfrm>
              <a:off x="4538949" y="4854947"/>
              <a:ext cx="374574" cy="2031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77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C4BC79F-0844-4BDC-A575-E7867C7B3703}"/>
                </a:ext>
              </a:extLst>
            </p:cNvPr>
            <p:cNvSpPr/>
            <p:nvPr/>
          </p:nvSpPr>
          <p:spPr>
            <a:xfrm rot="16200000">
              <a:off x="3026760" y="3447700"/>
              <a:ext cx="374574" cy="2031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77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B450CEE7-C1E0-4D3E-A17D-48AA82B17BC9}"/>
                </a:ext>
              </a:extLst>
            </p:cNvPr>
            <p:cNvCxnSpPr/>
            <p:nvPr/>
          </p:nvCxnSpPr>
          <p:spPr>
            <a:xfrm>
              <a:off x="3392730" y="4857756"/>
              <a:ext cx="194998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10606C6D-FE90-4AE5-8F73-7936AB9D05D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92730" y="3188290"/>
              <a:ext cx="0" cy="166542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FAAE1CE-53BA-4739-B2BA-6432289888B4}"/>
                </a:ext>
              </a:extLst>
            </p:cNvPr>
            <p:cNvSpPr txBox="1"/>
            <p:nvPr/>
          </p:nvSpPr>
          <p:spPr>
            <a:xfrm>
              <a:off x="4066520" y="4873106"/>
              <a:ext cx="360856" cy="2058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8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402E55E-FB0A-4533-8DAB-B252C2226D67}"/>
                </a:ext>
              </a:extLst>
            </p:cNvPr>
            <p:cNvSpPr txBox="1"/>
            <p:nvPr/>
          </p:nvSpPr>
          <p:spPr>
            <a:xfrm rot="16200000">
              <a:off x="2768344" y="3879527"/>
              <a:ext cx="1024752" cy="2058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778" b="1" dirty="0">
                  <a:latin typeface="Arial" panose="020B0604020202020204" pitchFamily="34" charset="0"/>
                  <a:cs typeface="Arial" panose="020B0604020202020204" pitchFamily="34" charset="0"/>
                </a:rPr>
                <a:t>OVA-Tet+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DF63AAD9-669E-40F8-B50B-052C2CAD1115}"/>
              </a:ext>
            </a:extLst>
          </p:cNvPr>
          <p:cNvSpPr txBox="1"/>
          <p:nvPr/>
        </p:nvSpPr>
        <p:spPr>
          <a:xfrm>
            <a:off x="1201187" y="3410786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1081D7C-5B9C-4F6F-8EF4-F640B2F489EF}"/>
              </a:ext>
            </a:extLst>
          </p:cNvPr>
          <p:cNvSpPr txBox="1"/>
          <p:nvPr/>
        </p:nvSpPr>
        <p:spPr>
          <a:xfrm>
            <a:off x="6246163" y="3434443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BFA7AA2-76AF-45B4-82E7-51FA4CB3269A}"/>
              </a:ext>
            </a:extLst>
          </p:cNvPr>
          <p:cNvSpPr txBox="1"/>
          <p:nvPr/>
        </p:nvSpPr>
        <p:spPr>
          <a:xfrm>
            <a:off x="640834" y="8402146"/>
            <a:ext cx="10910332" cy="1597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Fig. S2. Expression of TCRs in CD8+ T cells from pmel-1 (A, gp100-Tet+) or OT-I (B, OVA-Tet+) transgenic mice.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 Splenocytes from the mice were stained with tetramers binding with TCR  specific for gp100 (pmel-1) or OVA (OT-I), and antibody against CD8. Stained cells were analyzed with flow cytometry. The numbers in upright corner of the dot plots indicate the frequency (% of splenocytes) of gp100-targeting (</a:t>
            </a:r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) or OVA-targeting (</a:t>
            </a:r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) in CD8+ T cells.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742C596-BDDA-4C7F-89D9-CA71B84EB2F6}"/>
              </a:ext>
            </a:extLst>
          </p:cNvPr>
          <p:cNvSpPr/>
          <p:nvPr/>
        </p:nvSpPr>
        <p:spPr>
          <a:xfrm>
            <a:off x="5202655" y="3926885"/>
            <a:ext cx="745040" cy="5281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C5E5592-AD82-478E-83C3-E1F01FC22DCC}"/>
              </a:ext>
            </a:extLst>
          </p:cNvPr>
          <p:cNvSpPr txBox="1"/>
          <p:nvPr/>
        </p:nvSpPr>
        <p:spPr>
          <a:xfrm>
            <a:off x="5322544" y="3928664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27.8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5646C06-E0E5-48F0-8B25-1FCC889C63D4}"/>
              </a:ext>
            </a:extLst>
          </p:cNvPr>
          <p:cNvSpPr/>
          <p:nvPr/>
        </p:nvSpPr>
        <p:spPr>
          <a:xfrm>
            <a:off x="10254381" y="3926885"/>
            <a:ext cx="745040" cy="5281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68F78CD-D17A-4AF8-8EDE-D11759ED1CD3}"/>
              </a:ext>
            </a:extLst>
          </p:cNvPr>
          <p:cNvSpPr txBox="1"/>
          <p:nvPr/>
        </p:nvSpPr>
        <p:spPr>
          <a:xfrm>
            <a:off x="10374270" y="3928664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16.9</a:t>
            </a:r>
          </a:p>
        </p:txBody>
      </p:sp>
    </p:spTree>
    <p:extLst>
      <p:ext uri="{BB962C8B-B14F-4D97-AF65-F5344CB8AC3E}">
        <p14:creationId xmlns:p14="http://schemas.microsoft.com/office/powerpoint/2010/main" val="1034100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06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,Hong</dc:creator>
  <cp:lastModifiedBy>Jiang,Hong</cp:lastModifiedBy>
  <cp:revision>5</cp:revision>
  <dcterms:created xsi:type="dcterms:W3CDTF">2022-10-17T17:34:53Z</dcterms:created>
  <dcterms:modified xsi:type="dcterms:W3CDTF">2022-12-14T16:04:51Z</dcterms:modified>
</cp:coreProperties>
</file>